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000" autoAdjust="0"/>
    <p:restoredTop sz="94660"/>
  </p:normalViewPr>
  <p:slideViewPr>
    <p:cSldViewPr snapToGrid="0">
      <p:cViewPr varScale="1">
        <p:scale>
          <a:sx n="91" d="100"/>
          <a:sy n="91" d="100"/>
        </p:scale>
        <p:origin x="96" y="4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iuseppe%20Condor\Downloads\DurumWheat_RelativeLeafWaterContent_Updated%20April6%20(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Relative Water Content (RWC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[DurumWheat_RelativeLeafWaterContent_Updated April6 (1).xlsx]Graphs'!$N$14</c:f>
              <c:strCache>
                <c:ptCount val="1"/>
                <c:pt idx="0">
                  <c:v>GALLARETA</c:v>
                </c:pt>
              </c:strCache>
            </c:strRef>
          </c:tx>
          <c:spPr>
            <a:ln w="34925" cap="rnd">
              <a:solidFill>
                <a:schemeClr val="accent1"/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none"/>
          </c:marker>
          <c:cat>
            <c:strRef>
              <c:f>'[DurumWheat_RelativeLeafWaterContent_Updated April6 (1).xlsx]Graphs'!$O$13:$Q$13</c:f>
              <c:strCache>
                <c:ptCount val="3"/>
                <c:pt idx="0">
                  <c:v>24 March</c:v>
                </c:pt>
                <c:pt idx="1">
                  <c:v>27 March</c:v>
                </c:pt>
                <c:pt idx="2">
                  <c:v>31 March</c:v>
                </c:pt>
              </c:strCache>
            </c:strRef>
          </c:cat>
          <c:val>
            <c:numRef>
              <c:f>'[DurumWheat_RelativeLeafWaterContent_Updated April6 (1).xlsx]Graphs'!$O$14:$Q$14</c:f>
              <c:numCache>
                <c:formatCode>General</c:formatCode>
                <c:ptCount val="3"/>
                <c:pt idx="0">
                  <c:v>0.71</c:v>
                </c:pt>
                <c:pt idx="1">
                  <c:v>0.65</c:v>
                </c:pt>
                <c:pt idx="2">
                  <c:v>0.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0D8-48A5-A85C-B34FB31EF20F}"/>
            </c:ext>
          </c:extLst>
        </c:ser>
        <c:ser>
          <c:idx val="1"/>
          <c:order val="1"/>
          <c:tx>
            <c:strRef>
              <c:f>'[DurumWheat_RelativeLeafWaterContent_Updated April6 (1).xlsx]Graphs'!$N$15</c:f>
              <c:strCache>
                <c:ptCount val="1"/>
                <c:pt idx="0">
                  <c:v>KARIM</c:v>
                </c:pt>
              </c:strCache>
            </c:strRef>
          </c:tx>
          <c:spPr>
            <a:ln w="34925" cap="rnd">
              <a:solidFill>
                <a:schemeClr val="accent2"/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none"/>
          </c:marker>
          <c:cat>
            <c:strRef>
              <c:f>'[DurumWheat_RelativeLeafWaterContent_Updated April6 (1).xlsx]Graphs'!$O$13:$Q$13</c:f>
              <c:strCache>
                <c:ptCount val="3"/>
                <c:pt idx="0">
                  <c:v>24 March</c:v>
                </c:pt>
                <c:pt idx="1">
                  <c:v>27 March</c:v>
                </c:pt>
                <c:pt idx="2">
                  <c:v>31 March</c:v>
                </c:pt>
              </c:strCache>
            </c:strRef>
          </c:cat>
          <c:val>
            <c:numRef>
              <c:f>'[DurumWheat_RelativeLeafWaterContent_Updated April6 (1).xlsx]Graphs'!$O$15:$Q$15</c:f>
              <c:numCache>
                <c:formatCode>General</c:formatCode>
                <c:ptCount val="3"/>
                <c:pt idx="0">
                  <c:v>0.73</c:v>
                </c:pt>
                <c:pt idx="1">
                  <c:v>0.66</c:v>
                </c:pt>
                <c:pt idx="2">
                  <c:v>0.56999999999999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0D8-48A5-A85C-B34FB31EF20F}"/>
            </c:ext>
          </c:extLst>
        </c:ser>
        <c:ser>
          <c:idx val="2"/>
          <c:order val="2"/>
          <c:tx>
            <c:strRef>
              <c:f>'[DurumWheat_RelativeLeafWaterContent_Updated April6 (1).xlsx]Graphs'!$N$16</c:f>
              <c:strCache>
                <c:ptCount val="1"/>
                <c:pt idx="0">
                  <c:v>MEXICALI 75</c:v>
                </c:pt>
              </c:strCache>
            </c:strRef>
          </c:tx>
          <c:spPr>
            <a:ln w="34925" cap="rnd">
              <a:solidFill>
                <a:schemeClr val="accent3"/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none"/>
          </c:marker>
          <c:cat>
            <c:strRef>
              <c:f>'[DurumWheat_RelativeLeafWaterContent_Updated April6 (1).xlsx]Graphs'!$O$13:$Q$13</c:f>
              <c:strCache>
                <c:ptCount val="3"/>
                <c:pt idx="0">
                  <c:v>24 March</c:v>
                </c:pt>
                <c:pt idx="1">
                  <c:v>27 March</c:v>
                </c:pt>
                <c:pt idx="2">
                  <c:v>31 March</c:v>
                </c:pt>
              </c:strCache>
            </c:strRef>
          </c:cat>
          <c:val>
            <c:numRef>
              <c:f>'[DurumWheat_RelativeLeafWaterContent_Updated April6 (1).xlsx]Graphs'!$O$16:$Q$16</c:f>
              <c:numCache>
                <c:formatCode>General</c:formatCode>
                <c:ptCount val="3"/>
                <c:pt idx="0">
                  <c:v>0.69</c:v>
                </c:pt>
                <c:pt idx="1">
                  <c:v>0.57999999999999996</c:v>
                </c:pt>
                <c:pt idx="2">
                  <c:v>0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0D8-48A5-A85C-B34FB31EF20F}"/>
            </c:ext>
          </c:extLst>
        </c:ser>
        <c:ser>
          <c:idx val="3"/>
          <c:order val="3"/>
          <c:tx>
            <c:strRef>
              <c:f>'[DurumWheat_RelativeLeafWaterContent_Updated April6 (1).xlsx]Graphs'!$N$17</c:f>
              <c:strCache>
                <c:ptCount val="1"/>
                <c:pt idx="0">
                  <c:v>SVEVO</c:v>
                </c:pt>
              </c:strCache>
            </c:strRef>
          </c:tx>
          <c:spPr>
            <a:ln w="34925" cap="rnd">
              <a:solidFill>
                <a:schemeClr val="accent4"/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none"/>
          </c:marker>
          <c:cat>
            <c:strRef>
              <c:f>'[DurumWheat_RelativeLeafWaterContent_Updated April6 (1).xlsx]Graphs'!$O$13:$Q$13</c:f>
              <c:strCache>
                <c:ptCount val="3"/>
                <c:pt idx="0">
                  <c:v>24 March</c:v>
                </c:pt>
                <c:pt idx="1">
                  <c:v>27 March</c:v>
                </c:pt>
                <c:pt idx="2">
                  <c:v>31 March</c:v>
                </c:pt>
              </c:strCache>
            </c:strRef>
          </c:cat>
          <c:val>
            <c:numRef>
              <c:f>'[DurumWheat_RelativeLeafWaterContent_Updated April6 (1).xlsx]Graphs'!$O$17:$Q$17</c:f>
              <c:numCache>
                <c:formatCode>General</c:formatCode>
                <c:ptCount val="3"/>
                <c:pt idx="0">
                  <c:v>0.77</c:v>
                </c:pt>
                <c:pt idx="1">
                  <c:v>0.7</c:v>
                </c:pt>
                <c:pt idx="2">
                  <c:v>0.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0D8-48A5-A85C-B34FB31EF2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382203776"/>
        <c:axId val="1382207040"/>
      </c:lineChart>
      <c:catAx>
        <c:axId val="1382203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382207040"/>
        <c:crosses val="autoZero"/>
        <c:auto val="0"/>
        <c:lblAlgn val="ctr"/>
        <c:lblOffset val="100"/>
        <c:noMultiLvlLbl val="0"/>
      </c:catAx>
      <c:valAx>
        <c:axId val="1382207040"/>
        <c:scaling>
          <c:orientation val="minMax"/>
          <c:min val="0.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382203776"/>
        <c:crosses val="autoZero"/>
        <c:crossBetween val="between"/>
        <c:majorUnit val="0.05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58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298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931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67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844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2510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178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506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753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847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339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08F75-724B-4BCE-BC33-49C063DFA7A3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1607F-E4DE-4CA0-A1F1-74290059583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680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Documento_di_Microsoft_Word.doc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chart" Target="../charts/chart1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ggetto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6129120"/>
              </p:ext>
            </p:extLst>
          </p:nvPr>
        </p:nvGraphicFramePr>
        <p:xfrm>
          <a:off x="2890838" y="5043488"/>
          <a:ext cx="7226300" cy="2020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Documento" r:id="rId3" imgW="6488764" imgH="1814465" progId="Word.Document.12">
                  <p:embed/>
                </p:oleObj>
              </mc:Choice>
              <mc:Fallback>
                <p:oleObj name="Documento" r:id="rId3" imgW="6488764" imgH="1814465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90838" y="5043488"/>
                        <a:ext cx="7226300" cy="2020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uppo 3"/>
          <p:cNvGrpSpPr/>
          <p:nvPr/>
        </p:nvGrpSpPr>
        <p:grpSpPr>
          <a:xfrm>
            <a:off x="1636366" y="355175"/>
            <a:ext cx="9259160" cy="4686296"/>
            <a:chOff x="1288637" y="439496"/>
            <a:chExt cx="9259160" cy="4686296"/>
          </a:xfrm>
        </p:grpSpPr>
        <p:graphicFrame>
          <p:nvGraphicFramePr>
            <p:cNvPr id="6" name="Grafico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4837790"/>
                </p:ext>
              </p:extLst>
            </p:nvPr>
          </p:nvGraphicFramePr>
          <p:xfrm>
            <a:off x="3168203" y="1504792"/>
            <a:ext cx="5743977" cy="3621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" name="Rettangolo 2"/>
            <p:cNvSpPr/>
            <p:nvPr/>
          </p:nvSpPr>
          <p:spPr>
            <a:xfrm>
              <a:off x="1288637" y="439496"/>
              <a:ext cx="9259160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</a:t>
              </a:r>
              <a:r>
                <a: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 </a:t>
              </a:r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|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 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Water Content (RWC) of the flag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af in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ur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it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ltivars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llareta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Karim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Mexicali 75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US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vevo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</a:p>
            <a:p>
              <a:pPr algn="just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d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der conditions of increasing drought stress from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r>
                <a:rPr lang="en-US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 March 2017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Irrigation was stopped on 16 March 2017.</a:t>
              </a:r>
              <a:r>
                <a:rPr lang="it-IT" sz="1200" dirty="0" smtClean="0">
                  <a:latin typeface="Times New Roman"/>
                  <a:cs typeface="Times New Roman"/>
                </a:rPr>
                <a:t> </a:t>
              </a:r>
            </a:p>
            <a:p>
              <a:pPr algn="just"/>
              <a:r>
                <a:rPr lang="en-US" sz="1200" dirty="0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Analysis of variance (ANOVA) 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indicated significant (</a:t>
              </a:r>
              <a:r>
                <a:rPr 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P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&lt; 0.05) </a:t>
              </a:r>
              <a:r>
                <a:rPr lang="en-US" sz="1200" dirty="0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effects due to genotypes but not for the genotype x sampling date interaction.</a:t>
              </a:r>
            </a:p>
          </p:txBody>
        </p:sp>
        <p:sp>
          <p:nvSpPr>
            <p:cNvPr id="2" name="Rettangolo 1"/>
            <p:cNvSpPr/>
            <p:nvPr/>
          </p:nvSpPr>
          <p:spPr>
            <a:xfrm>
              <a:off x="4808067" y="4487043"/>
              <a:ext cx="737702" cy="2616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it-IT" sz="1100" b="0" cap="none" spc="0" dirty="0" smtClean="0">
                  <a:ln w="0"/>
                  <a:solidFill>
                    <a:schemeClr val="tx1">
                      <a:lumMod val="65000"/>
                      <a:lumOff val="35000"/>
                    </a:schemeClr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94 DAP)</a:t>
              </a:r>
              <a:endParaRPr lang="it-IT" sz="1100" b="0" cap="none" spc="0" dirty="0">
                <a:ln w="0"/>
                <a:solidFill>
                  <a:schemeClr val="tx1">
                    <a:lumMod val="65000"/>
                    <a:lumOff val="35000"/>
                  </a:schemeClr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ttangolo 6"/>
            <p:cNvSpPr/>
            <p:nvPr/>
          </p:nvSpPr>
          <p:spPr>
            <a:xfrm>
              <a:off x="6504099" y="4487043"/>
              <a:ext cx="737702" cy="2616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it-IT" sz="1100" b="0" cap="none" spc="0" dirty="0" smtClean="0">
                  <a:ln w="0"/>
                  <a:solidFill>
                    <a:schemeClr val="tx1">
                      <a:lumMod val="65000"/>
                      <a:lumOff val="35000"/>
                    </a:schemeClr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97 DAP)</a:t>
              </a:r>
              <a:endParaRPr lang="it-IT" sz="1100" b="0" cap="none" spc="0" dirty="0">
                <a:ln w="0"/>
                <a:solidFill>
                  <a:schemeClr val="tx1">
                    <a:lumMod val="65000"/>
                    <a:lumOff val="35000"/>
                  </a:schemeClr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ttangolo 8"/>
            <p:cNvSpPr/>
            <p:nvPr/>
          </p:nvSpPr>
          <p:spPr>
            <a:xfrm>
              <a:off x="8200131" y="4487043"/>
              <a:ext cx="808235" cy="2616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it-IT" sz="1100" b="0" cap="none" spc="0" dirty="0" smtClean="0">
                  <a:ln w="0"/>
                  <a:solidFill>
                    <a:schemeClr val="tx1">
                      <a:lumMod val="65000"/>
                      <a:lumOff val="35000"/>
                    </a:schemeClr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101 DAP)</a:t>
              </a:r>
              <a:endParaRPr lang="it-IT" sz="1100" b="0" cap="none" spc="0" dirty="0">
                <a:ln w="0"/>
                <a:solidFill>
                  <a:schemeClr val="tx1">
                    <a:lumMod val="65000"/>
                    <a:lumOff val="35000"/>
                  </a:schemeClr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72341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21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Documento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Emanuele Condorelli</cp:lastModifiedBy>
  <cp:revision>25</cp:revision>
  <dcterms:created xsi:type="dcterms:W3CDTF">2017-12-27T11:12:06Z</dcterms:created>
  <dcterms:modified xsi:type="dcterms:W3CDTF">2018-05-03T07:13:17Z</dcterms:modified>
</cp:coreProperties>
</file>